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2" r:id="rId3"/>
  </p:sldIdLst>
  <p:sldSz cx="6858000" cy="9144000" type="screen4x3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7" userDrawn="1">
          <p15:clr>
            <a:srgbClr val="A4A3A4"/>
          </p15:clr>
        </p15:guide>
        <p15:guide id="2" pos="515" userDrawn="1">
          <p15:clr>
            <a:srgbClr val="A4A3A4"/>
          </p15:clr>
        </p15:guide>
        <p15:guide id="3" orient="horz" pos="49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teve RAO" initials="SR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FD65B"/>
    <a:srgbClr val="FFFFFF"/>
    <a:srgbClr val="FF0000"/>
    <a:srgbClr val="DFFF00"/>
    <a:srgbClr val="FF6000"/>
    <a:srgbClr val="FF00BF"/>
    <a:srgbClr val="0040FF"/>
    <a:srgbClr val="00FF40"/>
    <a:srgbClr val="FFBF00"/>
    <a:srgbClr val="7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955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2025" y="45"/>
      </p:cViewPr>
      <p:guideLst>
        <p:guide orient="horz" pos="1927"/>
        <p:guide pos="515"/>
        <p:guide orient="horz" pos="49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commentAuthors" Target="commentAuthors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8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9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9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279660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119293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45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4" y="2241558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4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8" y="2241558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8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8" y="131657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6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8" y="131657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6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4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45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EC65DE-3256-4391-8B60-5FD8EB28308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45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45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F4A6F1-87A3-48A2-9EE5-8E9C41FA14CC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60215" y="868691"/>
            <a:ext cx="6630066" cy="6953620"/>
            <a:chOff x="160215" y="868691"/>
            <a:chExt cx="6630066" cy="6953620"/>
          </a:xfrm>
        </p:grpSpPr>
        <p:sp>
          <p:nvSpPr>
            <p:cNvPr id="2" name="TextBox 1"/>
            <p:cNvSpPr txBox="1"/>
            <p:nvPr/>
          </p:nvSpPr>
          <p:spPr>
            <a:xfrm>
              <a:off x="221530" y="7177151"/>
              <a:ext cx="6326423" cy="645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</a:t>
              </a:r>
              <a:r>
                <a: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 S1.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ucleotide and deduced amino acid sequence of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a cucumber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. </a:t>
              </a:r>
              <a:r>
                <a:rPr lang="en-US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eucospilot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IPK5, RIPK7, and MLKL. Positions of nucleotide and amino acid sequences are indicated on lift sides. The different colored amino acid sequences indicate the corresponding functional domains.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160215" y="868691"/>
              <a:ext cx="6630066" cy="5910370"/>
              <a:chOff x="160215" y="868691"/>
              <a:chExt cx="6630066" cy="5910370"/>
            </a:xfrm>
          </p:grpSpPr>
          <p:grpSp>
            <p:nvGrpSpPr>
              <p:cNvPr id="59" name="Group 58"/>
              <p:cNvGrpSpPr/>
              <p:nvPr/>
            </p:nvGrpSpPr>
            <p:grpSpPr>
              <a:xfrm>
                <a:off x="221530" y="954644"/>
                <a:ext cx="6568751" cy="5824417"/>
                <a:chOff x="171139" y="358297"/>
                <a:chExt cx="6568751" cy="5824417"/>
              </a:xfrm>
            </p:grpSpPr>
            <p:sp>
              <p:nvSpPr>
                <p:cNvPr id="15" name="矩形 14"/>
                <p:cNvSpPr/>
                <p:nvPr/>
              </p:nvSpPr>
              <p:spPr>
                <a:xfrm>
                  <a:off x="171139" y="570448"/>
                  <a:ext cx="2655571" cy="3103735"/>
                </a:xfrm>
                <a:prstGeom prst="rect">
                  <a:avLst/>
                </a:prstGeom>
              </p:spPr>
              <p:txBody>
                <a:bodyPr wrap="square" lIns="0" tIns="0" rIns="0" bIns="0">
                  <a:spAutoFit/>
                </a:bodyPr>
                <a:lstStyle/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 1 atgtctgggaggaggggagactcttcccgttcgagacaacgagatatttctcaagtgttcaagaattttgcaagccttagtaaacagttg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 1  M  S  G  R  R  G  D  S  S  R  S  R  Q  R  D  I  S  Q  V  F  K  N  F  A  S  L  S  K  Q  L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91 aagaaagtaatacatgattcgaacactacgctcgcagagttacagacaactggctcactggactttgacgaagactctcagaagaatttc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31  K  K  V  I  H  D  S  N  T  T  L  A  E  L  Q  T  T  G  S  L  D  F  D  E  D  S  Q  K  N  F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181 catctggaagaggtagaaagcagcttcatcagcactgtagtagcatcccagccaaggattctaatctttggacaatcattttcatctaa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61  H  L  E  E  V  E  S  S  F  I  S  T  V  V  A  S  Q  P  R  I  L  I  F  G  Q  S  F  S  S  K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271 gctgcattagtgaaccacttactaggtgaagagatcataactgtgccacctcctgggaccaaagatgacaaatcataccgactcatacg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91  A  A  L  V  N  H  L  L  G  E  E  I  I  T  V  P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P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P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G  T  K  D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D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K  S  Y  R  L  I  R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361 attaagtatggacagagaaggtgtaccagtctttccttaatggacaactttgaactaattgatcaaaatagtatcaatgtgcaagacag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121  I  K  Y  G  Q  R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R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C  T  S  L  S  L  M  D  N  F  E  L  I  D  Q  N  S  I  N  V  Q  D  R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451 gattgggaggtaataccagaatggcaggtcagaatccagccagaagtcaagtcccaggaccctgctgctaaagcaattacagatgtaac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151  D  W  E  V  I  P  E  W  Q  V  R  I  Q  P  E  V  K  S  Q  D  P  A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A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K  A  I  T  D  V  T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541 ttaaacaagcctctgttggcatacaatgttcagatagtagtgtcacctcacaatataccaggtgtgtcggttcacaagatctttgagaa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181  L  N  K  P  L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L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A  Y  N  V  Q  I  V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S  P  H  N  I  P  G  V  S  V  H  K  I  F  E  K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631 tgtgttggtgatggcatgccaatcttgttgtatgctcttgatggggacaatctctcaagagaatgtcagaacttcattttggatcttcgg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211  C  V  G  D  G  M  P  I  L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L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Y  A  L  D  G  D  N  L  S  R  E  C  Q  N  F  I  L  D  L  R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721 tcctgtgcccctgaatatcctctcctgtttgtagattgttgtttaaaatataggacttttaataggctgtcagttagaaaatctgttgat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241  S  C  A  P  E  Y  P  L  L  F  V  D  C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C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L  K  Y  R  T  F  N  R  L  S  V  R  K  S  V  D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811 tactcttccagtgattctcagagcccagaggattgtgaggatgattcagcatatgatacagatgaagtaggagccaaagggggacatag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271  Y  S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D  S  Q  S  P  E  D  C  E  D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D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S  A  Y  D  T  D  E  V  G  A  K  G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G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H  R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901 ccccagaggaacccaggtagagctgaaacatatcggcaggtttctttaatggctcaattgaaaaaccttggtttcttgaatgatgttggt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301  P  Q  R  N  P  G  R  A  E  T  Y  R  Q  V  S  L  M  A  Q  L  K  N  L  G  F  L  N  D  V  G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991 caggaattcaaggctgaaccgcatcgtgtatctagtaggtttgaaaatattcacaatggaccaggggtagtgcaatctatacaccacatg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331  Q  E  F  K  A  E  P  H  R  V  S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R  F  E  N  I  H  N  G  P  G  V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Q  S  I  H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H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M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081 cttcagtggtacctagttgaggcagcttcatatttacacaagcttcatttaaagtgtatgaatatgtttataatgactgcatttgatatg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361  L  Q  W  Y  L  V  E  A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A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S  Y  L  H  K  L  H  L  K  C  M  N  M  F  I  M  T  A  F  D  M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171 caaagagacattctgatcactccaaagaggatagagtttgcaaggaagagagaggcagaactttatgactccttaaaaggattagcaga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391  Q  R  D  I  L  I  T  P  K  R  I  E  F  A  R  K  R  E  A  E  L  Y  D  S  L  K  G  L  A  E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261 gagaggcaggtccagatcagtgtgatgatacgagagacggtggaaaacatggaggacgaattggtagaagaggctgtgaagtgtgacctt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421  E  R  Q  V  Q  I  S  V  M  I  R  E  T  V  E  N  M  E  D  E  L  V  E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E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A  V  K  C  D  L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351 agagatattgaagaaagtcaagaggtggaagggatttcccagagtaaagccgtcaaacaatgcacacattgtattaaggaattagtattg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451  R  D  I  E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E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S  Q  E  V  E  G  I  S  Q  S  K  A  V  K  Q  C  T  H  C  I  K  E  L  V  L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441 accagactccgggctgcagtggtggaacgcctggtaagctctgtggaccacctccaggacagctaccttgggaccctagagagatgcttg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481  T  R  L  R  A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A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V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E  R  L  V  S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V  D  H  L  Q  D  S  Y  L  G  T  L  E  R  C  L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531 cagagtttagagacagaagaggataaggagtcatcagcgagtcatgctcttcaaaagattctgaattcagcctatcaagttgaggtcagt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511  Q  S  L  E  T  E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E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D  K  E  S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A  S  H  A  L  Q  K  I  L  N  S  A  Y  Q  V  E  V  S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621 gtgcgatccagctcatctgttgtgaaggtgttctttgaaagaatgaaggaaattctgcagtctatgaaacctttcaaggcaccacctgct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541  V  R  S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V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K  V  F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F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E  R  M  K  E  I  L  Q  S  M  K  P  F  K  A  P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P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A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711 cttaatgaagaatggaagcagaaggttgctcgcaccatgattcacaaccttgacgatcacaaacttgccaagagtatttgttctcagttc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571  L  N  E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E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W  K  Q  K  V  A  R  T  M  I  H  N  L  D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D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H  K  L  A  K  S  I  C  S  Q  F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801 agaagtcgtcttcaaaactcccatgattcattccttgcatccttgcatcagctagaagctaaacactcaggccgtttggagaaaactga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601  R  S  R  L  Q  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N  S  H  D  S  F  L  A  S  L  H  Q  L  E  A  K  H  S  G  R  L  E  K  T  E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891 gagaagagaatgaaggtccgaaagcaccatgcacccgtactggccaggctggcccttgatagcacatctttcaaagataaagtcctacat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631  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E  K  R  M  K  V  R  K  H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H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A  P  V  L  A  R  L  A  L  D  S  T  S  F  K  D  K  V  L  H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981 ggaatgccaaagcttgaacgtgaaataggtagagggcagtatggcgtagtgtattcctgcaaggcctggggtagcctcacacagtgtgct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661  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G  M  P  K  L  E  R  E  I  G  R  G  Q  Y  G  V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Y  S  C  K  A  W  G  S  L  T  Q  C  A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071 gttaaatctgtggtaccacctgatgacaaacattggaatgacttggccatggaattccattacacaaggtcaattccacctcacaagag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691  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  K  S  V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P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P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D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D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K  H  W  N  D  L  A  M  E  F  H  Y  T  R  S  I  P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P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H  K  R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161 attgttgccattgctgggtcagtagttgatcagggttatggaggaggtggctgctccctggcagtacttcttattatggagagaatgca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721  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I  V  A  I  A  G  S  V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D  Q  G  Y  G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G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G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G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C  S  L  A  V  L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L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I  M  E  R  M  Q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251 agagatttgcattcaggaatcaagatgggtcttgatctgcctagtcgactgcaaatagccctagacgtagtggaagggatccgttacttg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751  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R  D  L  H  S  G  I  K  M  G  L  D  L  P  S  R  L  Q  I  A  L  D  V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E  G  I  R  Y  L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341 cacagcttgggacttgttcacagagatataaaacttaagaatgttttgctggatgcggcaaacagaggaaaaataactgaccttggcttt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781  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H  S  L  G  L  V  H  R  D  I  K  L  K  N  V  L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L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D  A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A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N  R  G  K  I  T  D  L  G  F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431 tgcaagccagaagctatgatgagtggcagtattgttggaactccaattcatatggctccagagttatttactggcaagtatgacaacagt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811  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C  K  P  E  A  M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M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S  G  S  I  V  G  T  P  I  H  M  A  P  E  L  F  T  G  K  Y  D  N  S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521 gtggatacctatgcatttggaattctcttctggtacattatagctggtcatgtcaagcttccccagaactttgagcagtgtcacaacaa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841  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  D  T  Y  A  F  G  I  L  F  W  Y  I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I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A  G  H  V  K  L  P  Q  N  F  E  Q  C  H  N  K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611 gaccacttgtggtcttccgtcaagaaaggtaccagaccagagagactgaggcattttgatgatgaatgttgggatctaatggtgagctgt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871  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D  H  L  W  S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V  K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K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G  T  R  P  E  R  L  R  H  F  D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D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E  C  W  D  L  M  V  S  C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701 tgggcaggagaaactacacatcgccctctacttggtgtagtgcatgagaggcttgaagctttgcactaccaagctttagcaagaattgc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901  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W  A  G  E  T  </a:t>
                  </a:r>
                  <a:r>
                    <a:rPr lang="en-US" altLang="zh-CN" sz="350" dirty="0" err="1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T</a:t>
                  </a:r>
                  <a:r>
                    <a:rPr lang="en-US" altLang="zh-CN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H  R  P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L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L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G  V 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H  E  R  L  E  A  L  H  Y  Q  A  L  A  R  I  A 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791 </a:t>
                  </a:r>
                  <a:r>
                    <a:rPr lang="en-US" altLang="zh-CN" sz="350" dirty="0" err="1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ccaaaagtgaccattcctgatatacagacagacccatcatgctaccaatga</a:t>
                  </a:r>
                  <a:endParaRPr lang="en-US" altLang="zh-CN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931  P  K  V  T  I  P  D  I  Q  T  D  P  S  C  Y  Q  *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70" name="矩形 69"/>
                <p:cNvSpPr/>
                <p:nvPr/>
              </p:nvSpPr>
              <p:spPr>
                <a:xfrm>
                  <a:off x="171448" y="4105442"/>
                  <a:ext cx="2607468" cy="1535677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square" lIns="0" tIns="0" rIns="0" bIns="0">
                  <a:spAutoFit/>
                </a:bodyPr>
                <a:lstStyle/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 1 atggatatgatgaaggtgggtgcccgtggagacttcgctatctgttcagggagatgctaccctacccctgtatctcacacacccagtgc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M  D  M  M  K  V  G  A  R  G  D  F  A  I  C  S  G  R  C  Y  P  T  P  V  S  H  T  P  S  A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91 gctagggtattacattttgatcgcacgataaaggaaaatatgcacagcctgctgatagatataaacgaagttttcttaagaaccaaaat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A  R  V  L  H  F  D  R  T  I  K  E  N  M  H  S  L  L  I  D  I  N  E  V  F  L  R  T  K  M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181 ttcttcgaaaagcttgaaaagtatgaaagtgacacagggattgtgatgttagtcaagagggttgtgaagtactacgagattgaacacaa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6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F  F  E  K  L  E  K  Y  E  S  D  T  G  I  V  M  L  V  K  R  V  V  K  Y  Y  E  I  E  H  K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271 tttaaggactttaatcggatgttggttgattttgaagatgacttacaagtaaaacaaaaggatattggctttgaagaggctatagatac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9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F  K  D  F  N  R  M  L  V  D  F  E  D  D  L  Q  V  K  Q  K  D  I  G  F  E  E  A  I  D  T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361 catttagtcgttcatactttgaggcaggagcaacagaaccgtgtcgctgacttcgagaattttaagaactttgtgatggaaagattcaa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2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H  L  V  V  H  T  L  R  Q  E  Q  Q  N  R  V  A  D  F  E  N  F  K  N  F  V  M  E  R  F  N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451 gaagaaaaggaacacagggaatttgtggaggagcatatgaggaagttgcagttttatgaaagacgcaatgaaaaacctttaagtgaggg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5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E  E  K  E  H  R  E  F  V  E  E  H  M  R  K  L  Q  F  Y  E  R  R  N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E  K  P  L  S  E  G </a:t>
                  </a:r>
                  <a:endParaRPr lang="zh-CN" altLang="en-US" sz="350" dirty="0">
                    <a:highlight>
                      <a:srgbClr val="F2ABA6"/>
                    </a:highlight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541 aattattggaccatacacactgctgtccttgacaaggagaaggtgacagtgaaaagaatcagagatgtaaatgaccataatgtacaggc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8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N  Y  W  T  I  H  T  A  V  L  D  K  E  K  V  T  V  K  R  I  R  D  V  N  D  H  N  V  Q  A </a:t>
                  </a:r>
                  <a:endParaRPr lang="zh-CN" altLang="en-US" sz="350" dirty="0">
                    <a:highlight>
                      <a:srgbClr val="F2ABA6"/>
                    </a:highlight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631 tcatttcaaaaagaaactgtgaatttgatgagattttctcgaggaagtattgttcgtgtaattggaatgtgtgatgaggaacatgagaa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1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  F  Q  K  E  T  V  N  L  M  R  F  S  R  G  S  I  V  R  V  I  G  M  C  D  E  E  H  E  K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721 tttcttgtccttgagtacatggagaagggtgatctcagtacccttcttcataactctggagagaaaatcagccttagcaacaaagttac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4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F  L  V  L  E  Y  M  E  K  G  D  L  S  T  L  L  H  N  S  G  E  K  I  S  L  S  N  K  V  T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811 ctagcaacaactgctgcaagggcattctatgtcatgagccacaaattggtccatacatctttgagaacagagaagtttcttgttgataa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7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L  A  T  T  A  A  R  A  F  Y  V  M  S  H  K  L  V  H  T  S  L  R  T  E  K  F  L  V  D  K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901 tactataccgctaagctttcaggtatgagatatgcaaaaacattttcctctgccaggagatatggtagcaaaaagccagtcgtcgatct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0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Y  Y  T  A  K  L  S  G  M  R  Y  A  K  T  F  S  S  A  R  R  Y  G  S  K  K  P  V  V  D  L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991 acgtgctaccttgcgcctgaactataccagccaagagagctctccccagaagttgatgtatatgggtttggaattgtcctttgggaaat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3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T  C  Y  L  A  P  E  L  Y  Q  P  R  E  L  S  P  E  V  D  V  Y  G  F  G  I  V  L  W  E  I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081 ttcacccaaacaaagccattttcaacattggccaaggagataggcaaagagccaactcatgcagaagtgaagaagtttgttgtacacga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6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F  T  Q  T  K  P  F  S  T  L  A  K  E  I  G  K  E  P  T  H  A  E  V  K  K  F  V  V  H  D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171 aaaggggaggagtacgatgttggcagtggtcccatagagaccatggtgggtgaaattatcagagactgcagggcattggacccaaagaa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9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K  G  E  E  Y  D  V  G  S  G  P  I  E  T  M  V  G  E  I  I  R  D  C  R  A  L  D  P  K  K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261 cgaccaagtgtgtcagaaattctgaatagactggaaaaggttgggaacgaactagaagacgaagaagatggctgtcagta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95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2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R  P  S  V  S  E  I  L  N  R  L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E  K  V  G  N  E  L  E  D  E  E  D  G  C  Q  *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72" name="文本框 71"/>
                <p:cNvSpPr txBox="1"/>
                <p:nvPr/>
              </p:nvSpPr>
              <p:spPr>
                <a:xfrm>
                  <a:off x="767172" y="358297"/>
                  <a:ext cx="1428587" cy="209288"/>
                </a:xfrm>
                <a:prstGeom prst="rect">
                  <a:avLst/>
                </a:prstGeom>
                <a:noFill/>
              </p:spPr>
              <p:txBody>
                <a:bodyPr wrap="square" lIns="0" tIns="27432" rIns="0" bIns="27432" rtlCol="0">
                  <a:spAutoFit/>
                </a:bodyPr>
                <a:lstStyle/>
                <a:p>
                  <a:pPr algn="ctr"/>
                  <a:r>
                    <a:rPr lang="zh-CN" altLang="en-US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H</a:t>
                  </a:r>
                  <a:r>
                    <a:rPr lang="en-US" altLang="zh-CN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. l</a:t>
                  </a:r>
                  <a:r>
                    <a:rPr lang="zh-CN" altLang="en-US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eucospilota </a:t>
                  </a:r>
                  <a:r>
                    <a:rPr lang="en-US" altLang="zh-CN" sz="1000" b="1" dirty="0">
                      <a:solidFill>
                        <a:srgbClr val="000099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RIPK5</a:t>
                  </a:r>
                  <a:endParaRPr lang="zh-CN" altLang="en-US" sz="1000" b="1" dirty="0">
                    <a:solidFill>
                      <a:srgbClr val="000099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  <a:rtl val="0"/>
                  </a:endParaRPr>
                </a:p>
              </p:txBody>
            </p:sp>
            <p:sp>
              <p:nvSpPr>
                <p:cNvPr id="74" name="文本框 73"/>
                <p:cNvSpPr txBox="1"/>
                <p:nvPr/>
              </p:nvSpPr>
              <p:spPr>
                <a:xfrm>
                  <a:off x="3859782" y="358297"/>
                  <a:ext cx="1813813" cy="209288"/>
                </a:xfrm>
                <a:prstGeom prst="rect">
                  <a:avLst/>
                </a:prstGeom>
                <a:noFill/>
              </p:spPr>
              <p:txBody>
                <a:bodyPr wrap="square" lIns="0" tIns="27432" rIns="0" bIns="27432" rtlCol="0">
                  <a:spAutoFit/>
                </a:bodyPr>
                <a:lstStyle/>
                <a:p>
                  <a:pPr algn="ctr"/>
                  <a:r>
                    <a:rPr lang="zh-CN" altLang="en-US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H</a:t>
                  </a:r>
                  <a:r>
                    <a:rPr lang="en-US" altLang="zh-CN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. l</a:t>
                  </a:r>
                  <a:r>
                    <a:rPr lang="zh-CN" altLang="en-US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eucospilota </a:t>
                  </a:r>
                  <a:r>
                    <a:rPr lang="en-US" altLang="zh-CN" sz="1000" b="1" dirty="0">
                      <a:solidFill>
                        <a:srgbClr val="000099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RIPK7</a:t>
                  </a:r>
                  <a:endParaRPr lang="zh-CN" altLang="en-US" sz="1000" b="1" dirty="0">
                    <a:solidFill>
                      <a:srgbClr val="000099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  <a:rtl val="0"/>
                  </a:endParaRPr>
                </a:p>
              </p:txBody>
            </p:sp>
            <p:sp>
              <p:nvSpPr>
                <p:cNvPr id="75" name="文本框 74"/>
                <p:cNvSpPr txBox="1"/>
                <p:nvPr/>
              </p:nvSpPr>
              <p:spPr>
                <a:xfrm>
                  <a:off x="839224" y="3894777"/>
                  <a:ext cx="1348115" cy="209288"/>
                </a:xfrm>
                <a:prstGeom prst="rect">
                  <a:avLst/>
                </a:prstGeom>
                <a:noFill/>
              </p:spPr>
              <p:txBody>
                <a:bodyPr wrap="square" lIns="0" tIns="27432" rIns="0" bIns="27432" rtlCol="0">
                  <a:spAutoFit/>
                </a:bodyPr>
                <a:lstStyle/>
                <a:p>
                  <a:pPr algn="ctr"/>
                  <a:r>
                    <a:rPr lang="zh-CN" altLang="en-US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H</a:t>
                  </a:r>
                  <a:r>
                    <a:rPr lang="en-US" altLang="zh-CN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. l</a:t>
                  </a:r>
                  <a:r>
                    <a:rPr lang="zh-CN" altLang="en-US" sz="10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eucospilota </a:t>
                  </a:r>
                  <a:r>
                    <a:rPr lang="en-US" altLang="zh-CN" sz="1000" b="1" dirty="0">
                      <a:solidFill>
                        <a:srgbClr val="000099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Times New Roman" panose="02020603050405020304"/>
                      <a:rtl val="0"/>
                    </a:rPr>
                    <a:t>MLKL</a:t>
                  </a:r>
                  <a:endParaRPr lang="zh-CN" altLang="en-US" sz="1000" b="1" dirty="0">
                    <a:solidFill>
                      <a:srgbClr val="000099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Times New Roman" panose="02020603050405020304"/>
                    <a:rtl val="0"/>
                  </a:endParaRPr>
                </a:p>
              </p:txBody>
            </p:sp>
            <p:sp>
              <p:nvSpPr>
                <p:cNvPr id="347" name="矩形 346"/>
                <p:cNvSpPr/>
                <p:nvPr/>
              </p:nvSpPr>
              <p:spPr>
                <a:xfrm>
                  <a:off x="2878708" y="559585"/>
                  <a:ext cx="3861182" cy="5130251"/>
                </a:xfrm>
                <a:prstGeom prst="rect">
                  <a:avLst/>
                </a:prstGeom>
              </p:spPr>
              <p:txBody>
                <a:bodyPr wrap="square" lIns="0" tIns="0" rIns="0" bIns="0">
                  <a:spAutoFit/>
                </a:bodyPr>
                <a:lstStyle/>
                <a:p>
                  <a:pPr>
                    <a:lnSpc>
                      <a:spcPct val="80000"/>
                    </a:lnSpc>
                  </a:pP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 1 atggaaggataccatggtcatatgccagtgttaaacatgatggaatcactgactctacatggtgaaaaccagctgtctggcctgtcaacattaaattccatgatgaatgcaagtcctaaacttctgacactgat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M  E  G  Y  H  G  H  M  P  V  L  N  M  M  E  S  L  T  L  H  G  E  N  Q  L  S  G  L  S  T  L  N  S  M  M  N  A  S  P  K  L  L  T  L  I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136 cagaaaaagaagaacatggcaagtattgtccacgaaatcatgaggttgtatgcagaaaatgcacagattcaatctactgcctgtcaaactgtatgctttttatcgcagtcagaagtttcacgcagtgcattgtt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Q  K  K  K  N  M  A  S  I  V  H  E  I  M  R  L  Y  A  E  N  A  Q  I  Q  S  T  A  C  Q  T  V  C  F  L  S  Q  S  E  V  S  R  S  A  L  L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271 aaggaggatctgattggctgcatcattgataccatgcagaagcaggagtttctgtctgatgtgacagtacaaagcagtgcatgcaaggccttaagacttttgctggaccatgatgacaatttacaagtggagtt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9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K  E  D  L  I  G  C  I  I  D  T  M  Q  K  Q  E  F  L  S  D  V  T  V  Q  S  S  A  C  K  A  L  R  L  L  L  D  H  D  D  N  L  Q  V  E  F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406 gttgaaagtgacaaccataaagtcatcattagtcttttatcatctgatgaaagaaatccttcagttttagaagaggctttgctgttactggcagttttagcttcccaagaagaaaattatgatatcatcttaca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3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V  E  S  D  N  H  K  V  I  I  S  L  L  S  S  D  E  R  N  P  S  V  L  E  E  A  L  L  L  L  A  V  L  A  S  Q  E  E  N  Y  D  I  I  L  Q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541 gcatctcagcatgtggtaccaactatcatgaaagcgtaccctgataatggaccactgcaggtagcatcatgtgcctttgtgaagaaccttgcgagaacagtggatagccagcagctgcttgtgatgaaaggagt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8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A  S  Q  H  V  V  P  T  I  M  K  A  Y  P  D  N  G  P  L  Q  V  A  S  C  A  F  V  K  N  L  A  R  T  V  D  S  Q  Q  L  L  V  M  K  G  V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676 taccccctcattcttcatgtctttagaaaattccacagtgaagtggatgcacagttgaatgcacttatggtgctcgataaaattgcaagagctgtcctcacagcacctcagtggttaggtcaaaggttagaaga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2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Y  P  L  I  L  H  V  F  R  K  F  H  S  E  V  D  A  Q  L  N  A  L  M  V  L  D  K  I  A  R  A  V  L  T  A  P  Q  W  L  G  Q  R  L  E  D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811 gactgctggttagttgaaacattttatgccatgacttaccatccaggcagtatagaatgtcagattttagcctgtaaagtgctttgcagtcttctacagcatcagcctgaaatcctggatggtattggggagga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7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D  C  W  L  V  E  T  F  Y  A  M  T  Y  H  P  G  S  I  E  C  Q  I  L  A  C  K  V  L  C  S  L  L  Q  H  Q  P  E  I  L  D  G  I  G  E  D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946 aacagctcttgcttagcaatagacaatgctgttctgacaggactgagactatatggagacatagagagggatgtttttgttgcttgtgccagggctgtgtatcatcttgctgtgaattccaggatgctacaata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1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N  S  S  C  L  A  I  D  N  A  V  L  T  G  L  R  L  Y  G  D  I  E  R  D  V  F  V  A  C  A  R  A  V  Y  H  L  A  V  N  S  R  M  L  Q  Y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081 catctggtgtgtaaaggtgctcattttgacattaaagagggtatgttatcctttgctgatgatgctggtgcccagggtgctgcatgtcaggctatcactggattatgtctgtcagtcatggagaataaggtcaa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6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H  L  V  C  K  G  A  H  F  D  I  K  E  G  M  L  S  F  A  D  D  A  G  A  Q  G  A  A  C  Q  A  I  T  G  L  C  L  S  V  M  E  N  K  V  K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216 tttgcacaaatggaaattcacgtccaagttttcacagttttgaagaagttctcctctgaaagaccattcttagatgaagcaataaggtgtattacatgcctggctgatgtgggggttgttcgtaaccagagtat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0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F  A  Q  M  E  I  H  V  Q  V  F  T  V  L  K  K  F  S  S  E  R  P  F  L  D  E  A  I  R  C  I  T  C  L  A  D  V  G  V  V  R  N  Q  S  M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351 gtggagggggtccatgaagtcttcatgcaggctatggtggacaaccaggatgatgtagccttccaggaactctgtttagaagccatgagtgtcctctcaagtgcagagggtatggtggatattttatgtgaggc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5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V  E  G  V  H  E  V  F  M  Q  A  M  V  D  N  Q  D  D  V  A  F  Q  E  L  C  L  E  A  M  S  V  L  S  S  A  E  G  M  V  D  I  L  C  E  A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486 ggacttctgaacaacaccattcacatcatggagaaattcagtcaatgtgaaaatatacaacagaagggcagtatactcttccagacactggtagctcatcagaagaccaacatcgacacccacctgtcaaaaca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9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G  L  L  N  N  T  I  H  I  M  E  K  F  S  Q  C  E  N  I  Q  Q  K  G  S  I  L  F  Q  T  L  V  A  H  Q  K  T  N  I  D  T  H  L  S  K  Q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621 gttgccatggcaattattcagtcaatgaacaagtttcaaaatgatgaaactgttttggcagagagttgtgtagctttgcagttgctagccgacaaatccgagagtatttccagggtattagttgacaatgaggt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54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V  A  M  A  I  I  Q  S  M  N  K  F  Q  N  D  E  T  V  L  A  E  S  C  V  A  L  Q  L  L  A  D  K  S  E  S  I  S  R  V  L  V  D  N  E  V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756 cattccgttctctttatggttcttgaaaaatatgagaccaatgaagttctggtggatttggcgtgtgaagttttgtacattctttgctgtagatgggatttcaagaatgagatgctcttgtgggcatgtaaaaa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58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H  S  V  L  F  M  V  L  E  K  Y  E  T  N  E  V  L  V  D  L  A  C  E  V  L  Y  I  L  C  C  R  W  D  F  K  </a:t>
                  </a:r>
                  <a:r>
                    <a:rPr lang="zh-CN" altLang="en-US" sz="350" dirty="0">
                      <a:highlight>
                        <a:srgbClr val="A9DC5E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N  E  M  L  L  W  A  C  K  N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891 aatctcaatcggggggtagaggtattacttcaattaggagctgatgtcaactcaggatgtggtagagagtctcctctttgctttgcttgtgaaaatgataatgtgaaaatgactatgttgatcttgcaacagaa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63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A9DC5E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N  L  N  R  G  V  E  V  L  L  Q  L  G  A  D  V  N  S  G  C  G  R  E  S  P  L  C  F  A  C  E  N  D  N  V  K  M  T  M  L  I  L  Q  Q  N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026 gtgagtgatatgcaaacagctctgaagtactgcttagagttggaatttcatcatctggtgggaatcctcctcaaatacattggctatgatcaggaaggtggcaatgttatttggagtagcctatccctaggtga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67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A9DC5E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V  S  D  M  Q  T  A  L  K  Y  C  L  E  L  E  F  H  H  L  V  G  I  L  L  K  Y  I  G  Y  D  Q  E  G  G  N  V  I  W  S  S  L  S  L  G  E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161 ctccatgcccggtggttttacccaactttcaccaaagagactgcgagaatatctctgtcacaaagtgtgacaactgtagattcagtgcataagttagcatctcgcatcctctcaaaagaagctaaaagagagaa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72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L  H  A  R  W  F  Y  P  T  F  T  K  E  T  A  R  I  S  L  S  Q  S  V  T  T  V  D  S  V  H  K  L  A  S  R  I  L  S  K  E  A  K  R  E  K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296 aggagtaagatgaagcacctgctcagtgagcaacagaagaggcggtcgtctctaagtctcctggagccaccatttatcctgtctgaacttgaagctggtgaaagtggacataatggtgtcatggaagaatctag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76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R  S  K  M  K  H  L  L  S  E  Q  Q  K  R  R  S  S  L  S  L  L  E  P  P  F  I  L  S  E  L  E  A  G  E  S  G  H  N  G  V  M  E  E  S  R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431 tttgatgtttcagatgcaggtggaacattggattcttctgaaataagtcccttacgtgatgagttcccttccccagatagacaggtcaaagaggaaagtttcactgaggtagactctaaaaaacgcccaccagc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81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F  D  V  S  D  A  G  G  T  L  D  S  S  E  I  S  P  L  R  D  E  F  P  S  P  D  R  Q  V  K  E  E  S  F  T  E  V  D  S  K  K  R  P  P  A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566 ctcactagggatagaaggtccacatctgtttcagaggaggttctttcaggttataaaatgggcagagagagattgtcgtccctggattcattgtcagagatcagaagaccaagcaatctgcttcctctgaggaa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85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L  T  R  D  R  R  S  T  S  V  S  E  E  V  L  S  G  Y  K  M  G  R  E  R  L  S  S  L  D  S  L  S  E  I  R  R  P  S  N  L  L  P  L  R  K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701 ccatctctctctagtgctgaattacctattaatgtggaagacccaagatggttgtcaagctttcaagagcctttgccagataagaatgccaaacctttccatgcatcgactccagacacaacctctctctctcc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90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P  S  L  S  S  A  E  L  P  I  N  V  E  D  P  R  W  L  S  S  F  Q  E  P  L  P  D  K  N  A  K  P  F  H  A  S  T  P  D  T  T  S  L  S  P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836 acgagacccaacagtttagggatgaatgaatctcttgtacttcctagtgcacagaagcagagaaagatttctgatgcttcaagcatatttgaggaaaatctttctcctttcttgagagcatcaagtcaacttgc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94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T  R  P  N  S  L  G  M  N  E  S  L  V  L  P  S  A  Q  K  Q  R  K  I  S  D  A  S  S  I  F  E  E  N  L  S  P  F  L  R  A  S  S  Q  L  A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971 ctctcaactgcagatgtgagtgaaagcagtgcctgggaagattacctgtctgatgctcagatgccagatcttgttccaagggatgtgtattccagtactccttacaggagcaatttgcgacgaagaagccagcg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99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L  S  T  A  D  V  S  E  S  S  A  W  E  D  Y  L  S  D  A  Q  M  P  D  L  V  P  R  D  V  Y  S  S  T  P  Y  R  S  N  L  R  R  R  S  Q  R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106 agtagccgcatgtcatctgtgtcaaccattagcagtgtagatggatatccttacatcacctacctgaatctatcatcgaatggcttctcttgcttgggaccacttattgctgaaagatccttactcttacagtt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03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S  S  R  M  S  S  V  S  T  I  S  S  V  D  G  Y  P  Y  I  T  Y  L  N  L  S  S  N  G  F  S  C  L  G  P  L  I  A  E  R  S  L  L  L  Q  F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241 caataccttaccaagctcgacatttctaaaaacaacctaacagaagtaccacatgaatttttccaggctttgcaggaattagagagtattgacatcagtagtaatcacctgaccatcttaccatcagaaatttt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08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Q  </a:t>
                  </a:r>
                  <a:r>
                    <a:rPr lang="zh-CN" altLang="en-US" sz="350" dirty="0">
                      <a:highlight>
                        <a:srgbClr val="64D67A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Y  L  T  K  L  D  I  S  K  N  N  L  T  E  V  P  H  E  F  F  Q  A  L  Q  E  L  E  S  I  D  I  S  S  N  H  L  T  I  L  P  S  E  I  L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376 agcttctgcaacaaactacagttgttgaatgtctccggtaatgagatgtacagtttacccagtagtctggaggattccagtaagagtcttcaagaaatggatttgtcccacaatgcaattggaggatgtccaga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12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64D67A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  F  C  N  K  L  Q  L  L  N  V  S  G  N  E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M  Y  S  L  P  S  S  L  E  D  S  S  K  S  L  Q  E  M  D  L  S  H  N  A  I  G  G  C  P  E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511 tggctgtctgattatttgccaaatttgaaaaacctgctccttcaaagctgcaatataacagtacttcctgatcaacctttaaagctgtcccatcttacaactctaaacctctcctacaactccatatctacaat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17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W  L  S  D  Y  L  </a:t>
                  </a:r>
                  <a:r>
                    <a:rPr lang="zh-CN" altLang="en-US" sz="350" dirty="0">
                      <a:highlight>
                        <a:srgbClr val="64D67A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P  N  L  K  N  L  L  L  Q  S  C  N  I  T  V  L  P  D  Q  P  L  K  L  S  H  L  T  T  L  N  L  S  Y  N  S  I  S  T  I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646 ccccctgcattttttaaagagtgtaacagcctcgatgtgttaaacctgtcttacaacaaaatagaaagcttgccagagaatgctgccattcacttgtcaaagctgagtgtgttaaaactgagcaataacaaact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21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64D67A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P  P  A  F  F  K  E  C  N  S  L  D  V  L  N  L  S  Y  N  K  I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E  S  L  P  E  N  A  A  I  H  L  S  K  L  S  V  L  K  L  S  N  N  K  L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781 ggaagtgtcataccagcctttatcctcagtctttcaagtctacgatgtgtagatttaagcagtaatggaatctcagtatgtgctgccccctatcagtggaagagtcagtcactcaaagaaatcaatctctctca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26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G  S  V  I  P  A  F  I  L  S  L  S  S  L  R  C  V  D  L  S  S  N  G  I  S  V  C  A  A  P  Y  Q  W  K  S  Q  S  L  K  E  I  N  L  S  H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3916 aataaaataaaagagttgagcctggataaaaagtttgacttgagaaactggttgaagatggaaaagttactactgtctcataataagttaagcaagataccaaaagaagtaggtcaactgacctccttgtgtac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30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N  K  I  K  E  L  S  L  D  K  K  F  D  L  R  N  W  L  K  M  E  K  L  L  L  S  H  N  K  L  S  K  I  P  K  E  V  G  Q  L  T  S  L  C  T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051 cttgatgtcagccataacaaggatatcaccaccattccagaccagcttggaactctttccaaattgtgggagtttcctttggatggcttaaagttggacctggaccctgccattaggaagagtagaaccaaaga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35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L  D  V  S  H  N  K  D  I  T  T  I  P  D  Q  L  G  T  L  S  K  L  W  E  F  P  L  D  G  L  K  L  D  L  D  P  A  I  R  K  S  R  T  K  D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186 atcattggatttctcaaccaaaaattaaaaaaggctgtgccttattttcgaatgaagttgatggtcgttggatatggaggaagagggaagtcatctctgctggccaggttgaggagggataagcagggtaaaaa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39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I  I  G  F  L  N  Q  K  L  K  </a:t>
                  </a:r>
                  <a:r>
                    <a:rPr lang="zh-CN" altLang="en-US" sz="350" dirty="0">
                      <a:highlight>
                        <a:srgbClr val="58B9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K  A  V  P  Y  F  R  M  K  L  M  V  V  G  Y  G  G  R  G  K  S  S  L  L  A  R  L  R  R  D  K  Q  G  K  K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321 agagtcagtactgccactgttggtatagatgttggtgaattgaaagtggaagtaatgcacaacaaaaagtctcaaacattccatttaacgacttgggacattgcaggtcaggaggatttttacagcacccatcc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44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58B9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R  V  S  T  A  T  V  G  I  D  V  G  E  L  K  V  E  V  M  H  N  K  K  S  Q  T  F  H  L  T  T  W  D  I  A  G  Q  E  D  F  Y  S  T  H  P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456 tgctttctgactggaagagcattgtttctggttgtctatgacttgcacaaaggcttagatgaggtgaagacaatcagaaactggttactaacgatccaagcattggcaccattcagtcctgtgattgttgtcgg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48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58B9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C  F  L  T  G  R  A  L  F  L  V  V  Y  D  L  H  K  G  L  D  E  V  K  T  I  R  N  W  L  L  T  I  Q  A  L  A  P  F  S  P  V  I  V  V  G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591 acccacaaagataaaattcctaaggaatatcagaacgagaagattcgagccatcagagacagaattaaagctctgtgtcttgccaggggatccccactgtagagtaggtttgccgaagtgtcatgtctacatga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53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58B9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T  H  K  D  K  I  P  K  E  Y  Q  N  E  K  I  R  A  I  R  D  R  I  K  A  L  C  L  A  R  G  F  P  T  V  E  R  F  A  E  V  S  C  L  H  E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726 gatattgacatggagaaactcagaaaggagattgttaatgcaatagaaagagctaccatcaaaggtcagccgattgttgggcagaagataccacacagctataagcttctggaagaattattccaagaggaagc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57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58B9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D  I  D  M  E  K  L  R  K  E  I  V  N  A  I  E  R  A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T  I  K  G  Q  P  I  V  G  Q  K  I  P  H  S  </a:t>
                  </a:r>
                  <a:r>
                    <a:rPr lang="zh-CN" altLang="en-US" sz="350" dirty="0">
                      <a:highlight>
                        <a:srgbClr val="66BCD4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Y  K  L  L  E  E  L  F  Q  E  E  A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861 cttcgtctgaaacttgctggtcaaaatccaattatggtacagagtgaagttctcaacagagtgaaagaaaaggaaatacctcttagtgaagaagaactggttcaggctgcaagatttcttcatgaaacaggtgt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62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66BCD4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L  R  L  K  L  A  G  Q  N  P  I  M  V  Q  S  E  V  L  N  R  V  K  E  K  E  I  P  L  S  E  E  E  L  V  Q  A  A  R  F  L  H  E  T  G  V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4996 atactacattatgatgatccagcactccacctagagaaccttttctttgttcagcctgagtggctgtgtaagatcatggcccaagtgattacggtcagagaaatcaacccatttatcaattctcagggggttat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66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66BCD4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I  L  H  Y  D  D  P  A  L  H  L  E  N  L  F  F  V  Q  P  E  W  L  C  K  I  M  A  Q  V  I  T  V  R  E  I  N  P  F  I  N  S  Q  G  V  M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5131 aggaagacagacatttatcagctaattaagagtactgtggatcaaagcagtcactttgtgaaaacctacattagtctgctggaaaagtttgaagttgctttacccatcagtgacaatgagctgctcattccttc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71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66BCD4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R  K  T  D  I  Y  Q  L  I  K  S  T  V  D  Q  S  S  H  F  V  K  T  Y  I  S  L  L  E  K  F  E  V  A  L  P  I  S  D  N  E  L  L  I  P  S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5266 aaggtcccagccaccagaccatcagttcaacttccaccaaaagaagagttacttcacaggtattacagaatgccgtacacaccagttggactctggccacgacttattttgaggctgcttcatttctccactga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75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66BCD4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K  V  P  A  T  R  P  S  V  Q  L  P  P  K  E  E  L  L  H  R  Y  Y  R  M  P  Y  T  P  V  G  L  W  P  R  L  I  L  R  L  L  H  F  S  T  D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5401 atgcttagtggggaagtaaatgaaaatgacagagatctaggctggacttctaaatactggaaggaagggatctttgtcagttggtcaaaggaagctttctttgtagtggattctgggaaggatgaagagactga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80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66BCD4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M  L  S  G  E  V  N  E  N  D  R  D  L  G  W  T  S  K  Y  W  K  E  G  I  F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V  S  W  S  K  E  A  F  F  V  V  D  S  G  K  D  E  E  T  E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5536 acaatttcaattgtagttcctttaacaaaattgggttacagggttcttggtcaagtgtgtgatcatttggatgatttaattgaagagtggttccctggactaaatgagttggacccgatgcttggcaccccact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84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T  I  S  I  V  V  P  L  T  K  L  G  Y  R  V  L  G  Q  V  C  D  H  L  D  D  L  I  E  E  W  F  P  G  L  N  E  L  D  P  M  L  G  T  P  L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5671 ctccagcgttgtgttccttgcatcaaatgtgatgttgctaatagcaaccaaaggccttatgagttttctatggatgaactgctagagcaggtccaacactgtgacaccattccctgcaagtatcatgccacacc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89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L  Q  R  C  V  P  C  I  K  C  D  V  A  N  S  N  Q  R  P  Y  E  F  S  M  D  E  L  L  E  Q  V  Q  H  C  D  T  I  P  C  K  Y  H  A  T  P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5806 gtgccaataaaattactggctcctgatgtgacttttgcagacctggaagacacatatcacattgacttgaagcatcttgcaattagttttgagaacattctcggagaaggcagttttggttctgtgtatgaggc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93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V  P  I  K  L  L  A  P  D  V  T  F  A  D  L  E  D  T  Y  H  I  D  L  K  H  L  A  I  S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F  E  N  I  L  G  E  G  S  F  G  S  V  Y  E  A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5941 aggtatcgaggaaagacagtcgctgtgaaaatgttctctgaccggtcaggaatacatcctcatcgtatgatgcgtcaagaggtgacagtcctacgtcatcttcagcatccgtgtttagtcagcatggagggtgt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198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R  Y  R  G  K  T  V  A  V  K  M  F  S  D  R  S  G  I  H  P  H  R  M  M  R  Q  E  V  T  V  L  R  H  L  Q  H  P  C  L  V  S  M  E  G  V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6076 tctttcagtccgaggatactggtcatggagttagctcccctgggttccttggggtctttattgacctcagagaaaggacaactcaacagaaagcttcagcacaagatagctatgcaggttgctgaaggattagcc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02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S  F  S  P  R  I  L  V  M  E  L  A  P  L  G  S  L  G  S  L  L  T  S  E  K  G  Q  L  N  R  K  L  Q  H  K  I  A  M  Q  V  A  E  G  L  A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6211 ttccttcatgaaaacaggatagtctacagagatctaaagcctgataacattcttatattttcacttctgccaggagcaagtcaaaatgtcaagatctcagattatgggatttccaagtttacaactccatatgg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07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F  L  H  E  N  R  I  V  Y  R  D  L  K  P  D  N  I  L  I  F  S  L  L  P  G  A  S  Q  N  V  K  I  S  D  Y  G  I  S  K  F  T  T  P  Y  G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6346 ttgaaagcctctgagggaacaccagggtacagggccccagaggtgatcaaggggacatcaacttataatacagaggtggatatattctcttatggcattctcctgtttgaggttgtaacagaaggacacaagcc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11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L  K  A  S  E  G  T  P  G  Y  R  A  P  E  V  I  K  G  T  S  T  Y  N  T  E  V  D  I  F  S  Y  G  I  L  L  F  E  V  V  T  E  G  H  K  P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6481 ttccaagatttagatttccgaactgaaatagaagaagctgttgttaagggaagaggaatgcctcagatcactgagtgtggtgttcctccatggccagatatgcaggacctcataaacaactgtacagaaaccat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16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F  Q  D  L  D  F  R  T  E  I  E  E  A  V  V  K  G  R  G  M  P  Q  I  T  E  C  G  V  P  P  W  P  D  M  Q  D  L  I  N  N  C  T  E  T  I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6616 ccacagaaaagaccaacggcaaaaatggccttaaagagattgcaatctgcggattttctttgtttgaagcagacgtatgctttagggtcaataaatgcagagtccatgaccgtcagacgatatcgaaagagcaa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20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F2ABA6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P  Q  K  R  P  T  A  K  M  A  L  K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R  L  Q  S  A  D  F  L  C  L  K  Q  T  Y  A  L  G  S  I  N  A  E  S  M  T  V  R  R  Y  R  K  S  K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6751 gactatgtccatgaagtttggatgactggaggggatggaacctctactgctgtgtcattaataaatccttttacttcaagctctaaagctcttgttcagggtgcaatgttaggtgagggacgaggtgtatgtat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25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D  Y  V  H  E  V  W  M  T  G  G  D  G  T  S  T  A  V  S  L  I  N  P  F  T  S  S  S  K  A  L  V  Q  G  A  M  L  G  E  G  R  G  V  C  I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6886 ctagcagctggagagaacttgatcattgtgggtacacaggaagggaaactttgtgtcattgaacccaccaaggacttttcaggtcccatcaaactgaaacacagcatcacagtggcagatgctgttctgtccct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29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L  A  A  G  </a:t>
                  </a:r>
                  <a:r>
                    <a:rPr lang="zh-CN" altLang="en-US" sz="350" dirty="0">
                      <a:highlight>
                        <a:srgbClr val="679AD3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E  N  L  I  I  V  G  T  Q  E  G  K  L  C  V  I  E  P  T  K  D  F  S  G  P  I  K  L  K  H  S  I  T  V  A  D  A  V  L  S  L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7021 attcatcagtcaagggctgataatgagggacgagttctagcagggctggcaaatggtaccctccttgtgtatgatgtctacacattgaagcatgtcccagatggaaaacctttgaaatcattacagctgaatgt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34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679AD3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I  H  Q  S  R  A  D  N  E  G  R  V  L  A  G  L  A  N  G  T  L  L  V  Y  D  V  Y  T  L  K  H  V  P  D  G  K  P  L  K  S  L  Q  L  N  V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7156 acatcctgtgatcctctcggatgcatggttctctatcaggctaaattgtatgtaggttgtggtaatcacatagcagtactaaatggagattcgttagaggtggaaagtcgtctcatcaaaaaccgtgcaaatgg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38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</a:t>
                  </a:r>
                  <a:r>
                    <a:rPr lang="zh-CN" altLang="en-US" sz="350" dirty="0">
                      <a:highlight>
                        <a:srgbClr val="679AD3"/>
                      </a:highlight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T  S  C  D  P  L  G  C  M  V  L  Y  Q  A  K  L  Y  V  G  C  G  N  H  I  A  V  L  N  G  D  S  L  E  V  E  S  R  L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I  K  N  R  A  N  G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7291 gaaagtgaacctggtcaggtgagactcatagcagtagacaagtcagtttgggtctgtaggagatatggtgaagacagccactttattgaagtttgggatccaggcaaagacaagattaaaacataccttgatatt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43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E  S  E  P  G  Q  V  R  L  I  A  V  D  K  S  V  W  V  C  R  R  Y  G  E  D  S  H  F  I  E  V  W  D  P  G  K  D  K  I  K  T  Y  L  D  I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7426 gcccgtctgctgcaagaacatgatccaagtttgacaaacaaacagtgtgatatcaaatcaatgatgctgcaggctaaaacggctttatgggttggtgtggctagtggtcatctggcacttattgaccgccatac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47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A  R  L  L  Q  E  H  D  P  S  L  T  N  K  Q  C  D  I  K  S  M  M  L  Q  A  K  T  A  L  W  V  G  V  A  S  G  H  L  A  L  I  D  R  H  T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7561 tcgaagttgataacattggttcacagatatacagaggctttgaggaccatagcaactgtgaaatctccagatcaaactaaaagttcatcaggtagtattgtcatgactgcagggaagggtttcttaaaaagacc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52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S  K  L  I  T  L  V  H  R  Y  T  E  A  L  R  T  I  A  T  V  K  S  P  D  Q  T  K  S  S  S  G  S  I  V  M  T  A  G  K  G  F  L  K  R  P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7696 gaatgtgcagacctaatagatgaagactgtgtccatgttttagtctgggatgctcagttgaagagtcaagtgcaatatgtccagagtgaaattgacaggcggaacagaggtggccagtccaactggcaaaaggtg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566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E  C  A  D  L  I  D  E  D  C  V  H  V  L  V  W  D  A  Q  L  K  S  Q  V  Q  Y  V  Q  S  E  I  D  R  R  N  R  G  G  Q  S  N  W  Q  K  V 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7831 cagctagctgttcgaactgttgctgctttccacaaatcacactga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  <a:p>
                  <a:pPr>
                    <a:lnSpc>
                      <a:spcPct val="80000"/>
                    </a:lnSpc>
                  </a:pPr>
                  <a:r>
                    <a:rPr lang="en-US" altLang="zh-CN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2611</a:t>
                  </a:r>
                  <a:r>
                    <a:rPr lang="zh-CN" altLang="en-US" sz="350" dirty="0">
                      <a:latin typeface="Courier New" panose="02070309020205020404" pitchFamily="49" charset="0"/>
                      <a:ea typeface="MS Gothic" panose="020B0609070205080204" pitchFamily="49" charset="-128"/>
                      <a:cs typeface="Courier New" panose="02070309020205020404" pitchFamily="49" charset="0"/>
                    </a:rPr>
                    <a:t>  Q  L  A  V  R  T  V  A  A  F  H  K  S  H  *</a:t>
                  </a:r>
                  <a:endParaRPr lang="zh-CN" altLang="en-US" sz="350" dirty="0">
                    <a:latin typeface="Courier New" panose="02070309020205020404" pitchFamily="49" charset="0"/>
                    <a:ea typeface="MS Gothic" panose="020B0609070205080204" pitchFamily="49" charset="-128"/>
                    <a:cs typeface="Courier New" panose="02070309020205020404" pitchFamily="49" charset="0"/>
                  </a:endParaRPr>
                </a:p>
              </p:txBody>
            </p:sp>
            <p:grpSp>
              <p:nvGrpSpPr>
                <p:cNvPr id="3" name="Group 2"/>
                <p:cNvGrpSpPr/>
                <p:nvPr/>
              </p:nvGrpSpPr>
              <p:grpSpPr>
                <a:xfrm>
                  <a:off x="691611" y="5673391"/>
                  <a:ext cx="4547139" cy="509323"/>
                  <a:chOff x="691611" y="5673391"/>
                  <a:chExt cx="4547139" cy="509323"/>
                </a:xfrm>
              </p:grpSpPr>
              <p:sp>
                <p:nvSpPr>
                  <p:cNvPr id="348" name="矩形 347"/>
                  <p:cNvSpPr/>
                  <p:nvPr/>
                </p:nvSpPr>
                <p:spPr>
                  <a:xfrm>
                    <a:off x="928257" y="5673391"/>
                    <a:ext cx="1480216" cy="49718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>
                      <a:lnSpc>
                        <a:spcPts val="1700"/>
                      </a:lnSpc>
                      <a:defRPr/>
                    </a:pPr>
                    <a:r>
                      <a:rPr lang="en-US" altLang="zh-CN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kinase / </a:t>
                    </a:r>
                    <a:r>
                      <a:rPr lang="en-US" altLang="zh-CN" sz="8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K_Tyr_Ser-Thr</a:t>
                    </a:r>
                    <a:endPara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lnSpc>
                        <a:spcPts val="1700"/>
                      </a:lnSpc>
                      <a:defRPr/>
                    </a:pPr>
                    <a:r>
                      <a:rPr lang="en-US" altLang="zh-CN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K</a:t>
                    </a:r>
                    <a:endPara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9" name="矩形 348"/>
                  <p:cNvSpPr/>
                  <p:nvPr/>
                </p:nvSpPr>
                <p:spPr>
                  <a:xfrm>
                    <a:off x="691611" y="5789593"/>
                    <a:ext cx="288000" cy="108000"/>
                  </a:xfrm>
                  <a:prstGeom prst="rect">
                    <a:avLst/>
                  </a:prstGeom>
                  <a:solidFill>
                    <a:srgbClr val="F2ABA6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0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51" name="矩形 350"/>
                  <p:cNvSpPr/>
                  <p:nvPr/>
                </p:nvSpPr>
                <p:spPr>
                  <a:xfrm>
                    <a:off x="691611" y="6013795"/>
                    <a:ext cx="288000" cy="108000"/>
                  </a:xfrm>
                  <a:prstGeom prst="rect">
                    <a:avLst/>
                  </a:prstGeom>
                  <a:solidFill>
                    <a:srgbClr val="A9DC5E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0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54" name="矩形 353"/>
                  <p:cNvSpPr/>
                  <p:nvPr/>
                </p:nvSpPr>
                <p:spPr>
                  <a:xfrm>
                    <a:off x="3096736" y="5789593"/>
                    <a:ext cx="288000" cy="108000"/>
                  </a:xfrm>
                  <a:prstGeom prst="rect">
                    <a:avLst/>
                  </a:prstGeom>
                  <a:solidFill>
                    <a:srgbClr val="64D67A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0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55" name="矩形 354"/>
                  <p:cNvSpPr/>
                  <p:nvPr/>
                </p:nvSpPr>
                <p:spPr>
                  <a:xfrm>
                    <a:off x="3096736" y="6006151"/>
                    <a:ext cx="288000" cy="108000"/>
                  </a:xfrm>
                  <a:prstGeom prst="rect">
                    <a:avLst/>
                  </a:prstGeom>
                  <a:solidFill>
                    <a:srgbClr val="58B9A6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0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56" name="矩形 355"/>
                  <p:cNvSpPr/>
                  <p:nvPr/>
                </p:nvSpPr>
                <p:spPr>
                  <a:xfrm>
                    <a:off x="4364056" y="5802432"/>
                    <a:ext cx="288000" cy="108000"/>
                  </a:xfrm>
                  <a:prstGeom prst="rect">
                    <a:avLst/>
                  </a:prstGeom>
                  <a:solidFill>
                    <a:srgbClr val="66BCD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0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57" name="矩形 356"/>
                  <p:cNvSpPr/>
                  <p:nvPr/>
                </p:nvSpPr>
                <p:spPr>
                  <a:xfrm>
                    <a:off x="3334129" y="5684821"/>
                    <a:ext cx="559692" cy="497893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>
                      <a:lnSpc>
                        <a:spcPts val="1700"/>
                      </a:lnSpc>
                    </a:pPr>
                    <a:r>
                      <a:rPr lang="en-US" altLang="zh-CN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RR</a:t>
                    </a:r>
                    <a:endPara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lnSpc>
                        <a:spcPts val="1700"/>
                      </a:lnSpc>
                    </a:pPr>
                    <a:r>
                      <a:rPr lang="en-US" altLang="zh-CN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OC</a:t>
                    </a:r>
                    <a:endPara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8" name="矩形 357"/>
                  <p:cNvSpPr/>
                  <p:nvPr/>
                </p:nvSpPr>
                <p:spPr>
                  <a:xfrm>
                    <a:off x="4608131" y="5677201"/>
                    <a:ext cx="630619" cy="497893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>
                      <a:lnSpc>
                        <a:spcPts val="1700"/>
                      </a:lnSpc>
                    </a:pPr>
                    <a:r>
                      <a:rPr lang="en-US" altLang="zh-CN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R</a:t>
                    </a:r>
                    <a:endPara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lnSpc>
                        <a:spcPts val="1700"/>
                      </a:lnSpc>
                    </a:pPr>
                    <a:r>
                      <a:rPr lang="en-US" altLang="zh-CN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D40</a:t>
                    </a:r>
                    <a:endPara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9" name="矩形 358"/>
                  <p:cNvSpPr/>
                  <p:nvPr/>
                </p:nvSpPr>
                <p:spPr>
                  <a:xfrm>
                    <a:off x="4362381" y="6006620"/>
                    <a:ext cx="288000" cy="108000"/>
                  </a:xfrm>
                  <a:prstGeom prst="rect">
                    <a:avLst/>
                  </a:prstGeom>
                  <a:solidFill>
                    <a:srgbClr val="679AD3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0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4" name="TextBox 3"/>
              <p:cNvSpPr txBox="1"/>
              <p:nvPr/>
            </p:nvSpPr>
            <p:spPr>
              <a:xfrm>
                <a:off x="160216" y="903844"/>
                <a:ext cx="343431" cy="184666"/>
              </a:xfrm>
              <a:prstGeom prst="rect">
                <a:avLst/>
              </a:prstGeom>
              <a:noFill/>
            </p:spPr>
            <p:txBody>
              <a:bodyPr wrap="square" lIns="91440" tIns="0" rIns="91440" bIns="0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2877101" y="868691"/>
                <a:ext cx="343431" cy="184666"/>
              </a:xfrm>
              <a:prstGeom prst="rect">
                <a:avLst/>
              </a:prstGeom>
              <a:noFill/>
            </p:spPr>
            <p:txBody>
              <a:bodyPr wrap="square" lIns="91440" tIns="0" rIns="91440" bIns="0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60215" y="4442211"/>
                <a:ext cx="343431" cy="184666"/>
              </a:xfrm>
              <a:prstGeom prst="rect">
                <a:avLst/>
              </a:prstGeom>
              <a:noFill/>
            </p:spPr>
            <p:txBody>
              <a:bodyPr wrap="square" lIns="91440" tIns="0" rIns="91440" bIns="0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mU5ZjMyODc1MmI5MzZjZGYwZmFmMDkwOWIxOTY5YmMifQ=="/>
</p:tagLst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25554</Words>
  <Application>WPS 演示</Application>
  <PresentationFormat>On-screen Show (4:3)</PresentationFormat>
  <Paragraphs>23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Courier New</vt:lpstr>
      <vt:lpstr>MS Gothic</vt:lpstr>
      <vt:lpstr>Times New Roman</vt:lpstr>
      <vt:lpstr>微软雅黑</vt:lpstr>
      <vt:lpstr>Arial Unicode MS</vt:lpstr>
      <vt:lpstr>Calibri Light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enfen</dc:creator>
  <cp:lastModifiedBy>cr</cp:lastModifiedBy>
  <cp:revision>321</cp:revision>
  <dcterms:created xsi:type="dcterms:W3CDTF">2022-11-06T02:36:00Z</dcterms:created>
  <dcterms:modified xsi:type="dcterms:W3CDTF">2024-09-29T12:33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72AAD731F1749B5B426B818767CD68F_12</vt:lpwstr>
  </property>
  <property fmtid="{D5CDD505-2E9C-101B-9397-08002B2CF9AE}" pid="3" name="KSOProductBuildVer">
    <vt:lpwstr>2052-12.1.0.17827</vt:lpwstr>
  </property>
</Properties>
</file>